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2" r:id="rId3"/>
    <p:sldId id="257" r:id="rId4"/>
    <p:sldId id="258" r:id="rId5"/>
    <p:sldId id="259" r:id="rId6"/>
    <p:sldId id="261" r:id="rId7"/>
    <p:sldId id="260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75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F9776F-3F04-4B90-B12C-CD139AFFF1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6FC5FC7-7839-49B6-8FA1-8B21FAED60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785BD3-9961-453A-92D4-130CEB8F7C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CBB27-76DD-472D-BF4D-D499CB8BDF6C}" type="datetimeFigureOut">
              <a:rPr lang="zh-CN" altLang="en-US" smtClean="0"/>
              <a:t>2020/7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739EA9D-B3A9-4F6F-8BC7-CE991CF08B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6B03C17-63EA-4E7E-A387-DEDC7A658B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3422-D4DD-43DB-B9E8-C9C132786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5503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810E62-1F8D-4974-B40F-0D9E3447F0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6FA17A1-070C-4819-A7F2-5367244F22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4E734CA-1ADE-4052-8B6A-F711734FB0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CBB27-76DD-472D-BF4D-D499CB8BDF6C}" type="datetimeFigureOut">
              <a:rPr lang="zh-CN" altLang="en-US" smtClean="0"/>
              <a:t>2020/7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7421B65-F4B8-4593-BF70-8D362952B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C8E6330-48A4-480B-A62E-66A9A22CB2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3422-D4DD-43DB-B9E8-C9C132786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01360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0F51A52-3ACC-46A7-8AD4-04F5A5E5B4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0A2045C-EE3E-49AB-9B7E-1A45A9D864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501FB68-881D-497E-98E3-64C4349EF6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CBB27-76DD-472D-BF4D-D499CB8BDF6C}" type="datetimeFigureOut">
              <a:rPr lang="zh-CN" altLang="en-US" smtClean="0"/>
              <a:t>2020/7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8BA274F-A9B6-45C8-B000-149653DD3A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E7FD632-354E-4BC8-B37F-AC9C4CCBF2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3422-D4DD-43DB-B9E8-C9C132786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5724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5E4AAED-272F-414A-8F27-29A87D91E2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A9DEB8E-FFA1-4F4F-AC3A-AEA564AE43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57D296B-6E88-43B8-8D0C-313004FCDC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CBB27-76DD-472D-BF4D-D499CB8BDF6C}" type="datetimeFigureOut">
              <a:rPr lang="zh-CN" altLang="en-US" smtClean="0"/>
              <a:t>2020/7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E535060-BA17-45B9-AF50-4432345E89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EA85DEC-160F-44AB-B08D-07D7A0DCD2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3422-D4DD-43DB-B9E8-C9C132786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48443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89445D-5EB6-4F99-81D5-49A11BB87E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33F2D9F-A29D-4895-886D-7ADF2BC474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F55A920-EF15-4364-B757-BB119D81EC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CBB27-76DD-472D-BF4D-D499CB8BDF6C}" type="datetimeFigureOut">
              <a:rPr lang="zh-CN" altLang="en-US" smtClean="0"/>
              <a:t>2020/7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72D07B5-8C56-46D3-8183-E5E3F668C1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9867EBF-80BF-467B-8896-13CDFFF0FB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3422-D4DD-43DB-B9E8-C9C132786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3341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55FFA84-20C6-4BB7-BA83-651AAEDEEE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C9A5E19-82A8-463E-89C3-29BDA474A0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D3C103B-C07E-47F4-AC5D-ACCADDF362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A795EF9-D364-4046-B922-1B92B35040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CBB27-76DD-472D-BF4D-D499CB8BDF6C}" type="datetimeFigureOut">
              <a:rPr lang="zh-CN" altLang="en-US" smtClean="0"/>
              <a:t>2020/7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B4055C9-3E18-4341-938A-6E8F1B638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1439372-0433-4485-886A-E515F9019A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3422-D4DD-43DB-B9E8-C9C132786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92431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75A8606-8101-4A19-8CC9-0EDD27FA34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E5685AE-239C-4D77-8424-47AA776749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E38C68F-420E-4C4A-8EA4-5BC71C2D10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1B1BFE6-CA88-4E56-ABDC-1007C525204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5EBF40E-EC73-4B02-A181-441F31C37C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662CFB1-D5F9-403C-83CE-3C3BB01A5F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CBB27-76DD-472D-BF4D-D499CB8BDF6C}" type="datetimeFigureOut">
              <a:rPr lang="zh-CN" altLang="en-US" smtClean="0"/>
              <a:t>2020/7/2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122B98C-A659-407B-810A-61D6A9671E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F97BEF3-F764-4371-BBCE-685AA31C3A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3422-D4DD-43DB-B9E8-C9C132786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75992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C91B78-EEFF-4F74-A699-C01DE3CF0A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D28B49E-CC43-4340-8EC9-61F6FBE50D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CBB27-76DD-472D-BF4D-D499CB8BDF6C}" type="datetimeFigureOut">
              <a:rPr lang="zh-CN" altLang="en-US" smtClean="0"/>
              <a:t>2020/7/2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1B975E9-8AF8-48A2-BDA9-64C02D66A5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9EDFBDA-0B08-4E2E-B4DC-4E748BCBA6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3422-D4DD-43DB-B9E8-C9C132786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79459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91BFA12-D888-4A5B-B93E-559CA606CB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CBB27-76DD-472D-BF4D-D499CB8BDF6C}" type="datetimeFigureOut">
              <a:rPr lang="zh-CN" altLang="en-US" smtClean="0"/>
              <a:t>2020/7/2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D655A49-A126-4F8F-8FF3-6608E2FADD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50BAE65-649C-4F44-B9F3-C796F1B845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3422-D4DD-43DB-B9E8-C9C132786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31329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6F405F-6A2D-47C0-A5E0-9C46943B18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91DDD58-DE48-4FED-BA31-B4BE730B8A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C488AB2-0FBB-4EEC-9272-3F51518C67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2CCA360-BECC-4B47-B96F-D26E92A81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CBB27-76DD-472D-BF4D-D499CB8BDF6C}" type="datetimeFigureOut">
              <a:rPr lang="zh-CN" altLang="en-US" smtClean="0"/>
              <a:t>2020/7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CAD65D8-0D74-4B03-9B1A-A8F5045BD2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4ADD31F-B07C-4F31-9EAD-DA402CA85D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3422-D4DD-43DB-B9E8-C9C132786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38992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2E1D7F-4F85-4DCF-91A8-681BB5CA2D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F96F79D-3B33-453B-8AE8-601518F5E52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6EFBEBF-F1A9-4F43-AF1B-AA28B1E0A6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DBA4D3C-56A1-4F5E-9B17-5EA2DF8A7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CBB27-76DD-472D-BF4D-D499CB8BDF6C}" type="datetimeFigureOut">
              <a:rPr lang="zh-CN" altLang="en-US" smtClean="0"/>
              <a:t>2020/7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A850FE5-7C1D-4A97-8A6C-1298E2A6F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B9136B6-ACB8-45BD-8363-5F51F51EDE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703422-D4DD-43DB-B9E8-C9C132786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71929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62A77EDF-D79A-4E0C-BDB5-529016AED9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0C6D685-0349-4F88-865E-18A2605115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C0C6939-F0EE-443F-B10B-5EE2CA5157E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1CBB27-76DD-472D-BF4D-D499CB8BDF6C}" type="datetimeFigureOut">
              <a:rPr lang="zh-CN" altLang="en-US" smtClean="0"/>
              <a:t>2020/7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9F6A3FF-ED3F-49FA-8652-51A48F4348B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6EB0F91-E1BC-4986-804F-F4D01CF10D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703422-D4DD-43DB-B9E8-C9C132786FC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1164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5" name="图片 47" descr="Figure3-72">
            <a:extLst>
              <a:ext uri="{FF2B5EF4-FFF2-40B4-BE49-F238E27FC236}">
                <a16:creationId xmlns:a16="http://schemas.microsoft.com/office/drawing/2014/main" id="{FFD2B4AB-C835-4E0B-83A2-AECA3A46107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40364" y="426638"/>
            <a:ext cx="4557280" cy="45572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D96A207C-2DF4-4F66-A8B2-9A125E4256FF}"/>
              </a:ext>
            </a:extLst>
          </p:cNvPr>
          <p:cNvSpPr txBox="1"/>
          <p:nvPr/>
        </p:nvSpPr>
        <p:spPr>
          <a:xfrm>
            <a:off x="2632364" y="5292436"/>
            <a:ext cx="6336145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1. The K value is determined by elbow method.</a:t>
            </a:r>
            <a:endParaRPr lang="en-US" altLang="zh-CN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4810374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5D3556D4-4F2F-4683-95DB-46E9A48A8C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5" name="Rectangle 3">
            <a:extLst>
              <a:ext uri="{FF2B5EF4-FFF2-40B4-BE49-F238E27FC236}">
                <a16:creationId xmlns:a16="http://schemas.microsoft.com/office/drawing/2014/main" id="{F653A034-77B6-4FC5-99DB-FA9A45EA46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36640" y="5954198"/>
            <a:ext cx="7895976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The K value is determined by elbow method for the differential genes. 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1E218684-E5BC-4137-9318-35BECBB4E27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5019" y="376382"/>
            <a:ext cx="5340927" cy="53409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87827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9" name="图片 2" descr="Figure12-72">
            <a:extLst>
              <a:ext uri="{FF2B5EF4-FFF2-40B4-BE49-F238E27FC236}">
                <a16:creationId xmlns:a16="http://schemas.microsoft.com/office/drawing/2014/main" id="{E986CF73-C564-42CC-89A2-34C9126F848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36944" y="228600"/>
            <a:ext cx="5228417" cy="52284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1DF6B3EF-58C6-4A05-8AC2-7F48B32538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388F70FB-0A79-40FB-AF41-3A0C06F525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29407" y="6055692"/>
            <a:ext cx="6755054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Enrichment analysis of differential genes.</a:t>
            </a:r>
          </a:p>
        </p:txBody>
      </p:sp>
    </p:spTree>
    <p:extLst>
      <p:ext uri="{BB962C8B-B14F-4D97-AF65-F5344CB8AC3E}">
        <p14:creationId xmlns:p14="http://schemas.microsoft.com/office/powerpoint/2010/main" val="1945217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B840E409-2A6A-485B-9B8F-0122650A22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pic>
        <p:nvPicPr>
          <p:cNvPr id="3073" name="图片 70">
            <a:extLst>
              <a:ext uri="{FF2B5EF4-FFF2-40B4-BE49-F238E27FC236}">
                <a16:creationId xmlns:a16="http://schemas.microsoft.com/office/drawing/2014/main" id="{7093B852-EC2A-4AED-82AC-4EA00BC72D9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27562" y="697300"/>
            <a:ext cx="6463899" cy="4851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>
            <a:extLst>
              <a:ext uri="{FF2B5EF4-FFF2-40B4-BE49-F238E27FC236}">
                <a16:creationId xmlns:a16="http://schemas.microsoft.com/office/drawing/2014/main" id="{D99B28EA-F254-4D75-A579-8DDAED4CCE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59720" y="5788800"/>
            <a:ext cx="8452862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Overview of gene mutations in pancreatic cancer.</a:t>
            </a:r>
          </a:p>
        </p:txBody>
      </p:sp>
    </p:spTree>
    <p:extLst>
      <p:ext uri="{BB962C8B-B14F-4D97-AF65-F5344CB8AC3E}">
        <p14:creationId xmlns:p14="http://schemas.microsoft.com/office/powerpoint/2010/main" val="3063770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7" name="图片 3">
            <a:extLst>
              <a:ext uri="{FF2B5EF4-FFF2-40B4-BE49-F238E27FC236}">
                <a16:creationId xmlns:a16="http://schemas.microsoft.com/office/drawing/2014/main" id="{7D3CA2A0-D256-406B-913F-C4EE85E9E2D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53962" y="399115"/>
            <a:ext cx="7708948" cy="513466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>
            <a:extLst>
              <a:ext uri="{FF2B5EF4-FFF2-40B4-BE49-F238E27FC236}">
                <a16:creationId xmlns:a16="http://schemas.microsoft.com/office/drawing/2014/main" id="{8C4594A6-1132-4ECC-8886-80DDE9E45E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37146" y="5862485"/>
            <a:ext cx="849355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. Differential expression of miRNA volcano map.</a:t>
            </a:r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E3D15EE7-A8E4-4312-862D-217CA10963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08436" y="73891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44226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CE4D1DE2-A333-471B-8EEC-BC4F177E123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92220" y="1229710"/>
            <a:ext cx="6096000" cy="43985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8BE8B3D5-7729-491B-A93F-698D76F9A328}"/>
              </a:ext>
            </a:extLst>
          </p:cNvPr>
          <p:cNvSpPr/>
          <p:nvPr/>
        </p:nvSpPr>
        <p:spPr>
          <a:xfrm>
            <a:off x="2569620" y="5782178"/>
            <a:ext cx="5447543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. mRNA's volcano map. 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51169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:a16="http://schemas.microsoft.com/office/drawing/2014/main" id="{5DE69017-2614-40ED-9E61-1D5E2553C6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pic>
        <p:nvPicPr>
          <p:cNvPr id="5121" name="图片 84">
            <a:extLst>
              <a:ext uri="{FF2B5EF4-FFF2-40B4-BE49-F238E27FC236}">
                <a16:creationId xmlns:a16="http://schemas.microsoft.com/office/drawing/2014/main" id="{678ECE15-1063-43CB-A247-84D497720A8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91357" y="1717964"/>
            <a:ext cx="5802498" cy="38648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>
            <a:extLst>
              <a:ext uri="{FF2B5EF4-FFF2-40B4-BE49-F238E27FC236}">
                <a16:creationId xmlns:a16="http://schemas.microsoft.com/office/drawing/2014/main" id="{B9A45C2E-B95B-443C-BF17-0F3FC8825C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78890" y="5800574"/>
            <a:ext cx="5693054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7b. Volcanic map of differential methylation sites.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80">
            <a:extLst>
              <a:ext uri="{FF2B5EF4-FFF2-40B4-BE49-F238E27FC236}">
                <a16:creationId xmlns:a16="http://schemas.microsoft.com/office/drawing/2014/main" id="{29CBA9A9-1341-4CD2-9571-9DA6D7EA245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3502" y="1383244"/>
            <a:ext cx="5866504" cy="39074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3">
            <a:extLst>
              <a:ext uri="{FF2B5EF4-FFF2-40B4-BE49-F238E27FC236}">
                <a16:creationId xmlns:a16="http://schemas.microsoft.com/office/drawing/2014/main" id="{86BB4008-E31D-40C3-B3EB-4AD53ADBA4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8859" y="5800574"/>
            <a:ext cx="5802498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7a. Heat map of differentially expressed genes.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23530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6</TotalTime>
  <Words>93</Words>
  <Application>Microsoft Office PowerPoint</Application>
  <PresentationFormat>宽屏</PresentationFormat>
  <Paragraphs>8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2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高 天威</dc:creator>
  <cp:lastModifiedBy>高 天威</cp:lastModifiedBy>
  <cp:revision>22</cp:revision>
  <dcterms:created xsi:type="dcterms:W3CDTF">2020-05-06T06:16:23Z</dcterms:created>
  <dcterms:modified xsi:type="dcterms:W3CDTF">2020-07-23T01:49:40Z</dcterms:modified>
</cp:coreProperties>
</file>